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  <p:sldId id="279" r:id="rId4"/>
    <p:sldId id="282" r:id="rId5"/>
    <p:sldId id="278" r:id="rId6"/>
    <p:sldId id="276" r:id="rId7"/>
    <p:sldId id="275" r:id="rId8"/>
    <p:sldId id="281" r:id="rId9"/>
    <p:sldId id="280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19" clrIdx="0"/>
  <p:cmAuthor id="2" name="Microsoft Office User" initials="MOU [2]" lastIdx="1" clrIdx="1"/>
  <p:cmAuthor id="3" name="Microsoft Office User" initials="MOU [3]" lastIdx="1" clrIdx="2"/>
  <p:cmAuthor id="4" name="Microsoft Office User" initials="MOU [4]" lastIdx="1" clrIdx="3"/>
  <p:cmAuthor id="5" name="Microsoft Office User" initials="MOU [5]" lastIdx="1" clrIdx="4"/>
  <p:cmAuthor id="6" name="Microsoft Office User" initials="MOU [6]" lastIdx="1" clrIdx="5"/>
  <p:cmAuthor id="7" name="Microsoft Office User" initials="MOU [7]" lastIdx="1" clrIdx="6"/>
  <p:cmAuthor id="8" name="Microsoft Office User" initials="MOU [8]" lastIdx="1" clrIdx="7"/>
  <p:cmAuthor id="9" name="Microsoft Office User" initials="MOU [9]" lastIdx="1" clrIdx="8"/>
  <p:cmAuthor id="10" name="Microsoft Office User" initials="MOU [10]" lastIdx="1" clrIdx="9"/>
  <p:cmAuthor id="11" name="Microsoft Office User" initials="MOU [11]" lastIdx="1" clrIdx="10"/>
  <p:cmAuthor id="12" name="Microsoft Office User" initials="MOU [12]" lastIdx="1" clrIdx="11"/>
  <p:cmAuthor id="13" name="Microsoft Office User" initials="MOU [13]" lastIdx="1" clrIdx="12"/>
  <p:cmAuthor id="14" name="Microsoft Office User" initials="MOU [14]" lastIdx="1" clrIdx="13"/>
  <p:cmAuthor id="15" name="Janna Heide" initials="JH" lastIdx="6" clrIdx="14"/>
  <p:cmAuthor id="16" name="Schulze-Zur-Wiesch, Julian" initials="SJ" lastIdx="21" clrIdx="15">
    <p:extLst>
      <p:ext uri="{19B8F6BF-5375-455C-9EA6-DF929625EA0E}">
        <p15:presenceInfo xmlns:p15="http://schemas.microsoft.com/office/powerpoint/2012/main" userId="S-1-5-21-3318039502-754001453-826411437-26037" providerId="AD"/>
      </p:ext>
    </p:extLst>
  </p:cmAuthor>
  <p:cmAuthor id="17" name="AG Schulze zur Wie" initials="ASzW" lastIdx="5" clrIdx="16">
    <p:extLst>
      <p:ext uri="{19B8F6BF-5375-455C-9EA6-DF929625EA0E}">
        <p15:presenceInfo xmlns:p15="http://schemas.microsoft.com/office/powerpoint/2012/main" userId="AG Schulze zur Wi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2" autoAdjust="0"/>
    <p:restoredTop sz="94660"/>
  </p:normalViewPr>
  <p:slideViewPr>
    <p:cSldViewPr snapToGrid="0">
      <p:cViewPr varScale="1">
        <p:scale>
          <a:sx n="85" d="100"/>
          <a:sy n="85" d="100"/>
        </p:scale>
        <p:origin x="94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72C27A-D22A-43A7-BA51-03D14105E6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A6EED2B-6BFF-45DC-B281-4C26DC482C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E6877E-D35A-4DD2-A0B8-FBBD59CCA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37BCB0-097F-4549-BC12-EC67F9008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700D97E-CA5C-48E7-A305-85E470018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6950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62ACEE4-E887-483B-825E-D10B5F9E4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6B7B1A6-DB09-4F23-8A65-0203CC990C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DD8BA0C-E86B-4858-A71B-C580AC88C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25E0116-64C7-4C7D-BAD6-309DD4760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1D0528-37B0-4B00-876F-36973E9DD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6601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AD65FEA-8EB2-4CCF-8ECF-855B091735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1E49CB1-8E04-4202-A270-0E851A69B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7A6B54D-A1C5-4007-BB0B-ED727F487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1A2935B-3DED-47EE-8E89-C6CA92575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54CBF28-74EC-4D15-A1E5-708AD6139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8507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7431DE-8A59-46E6-90F2-A0DFC4B65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A2AC3AD-3EE4-4570-8321-86FD60660D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ED53DFA-301E-4981-A6E3-25C5D88C0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C1071B9-C77F-4FEB-BA4F-89191BF8F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4BE9CC6-51D2-4EA1-A512-B9CA702C3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1366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8E8F14-A91F-43E2-A811-37E08CDE9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70DA19B-8B4A-49AC-AD66-9091EAA66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028B8C7-E581-4760-B93D-4BC83D6C8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D64135E-3F22-48A0-B9CC-7DB1351A3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BD6F1D-1781-4A18-9FA1-0FC7FC83F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900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B1075C-23CF-497B-8E88-08AA06525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FEE633B-0EDF-479D-8E37-71224B68AA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B62DC91-DCE6-4323-A4D9-919D617473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6D4B807-5AB4-48C0-B4BD-5732D0E95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A110A02-7408-496E-BC18-086AE2E45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AF6E0B3-C189-4F5C-A337-B359B87BF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197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45860E2-846B-4CAD-9523-65B0F4299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DA839F4-3BBC-4D87-A531-FF1E869BE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5ED83E7-7883-4F74-B448-4EF8797CB5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7B48097A-FC95-4300-9AEB-588EFBBFA3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D478A23-A79F-4074-AF6C-40FE37CD05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B8E9A4F-275F-4027-B1CC-976263BE4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255B3AF-304F-43DC-9FF1-8BA108E16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FD78DF5F-9DC9-4ECB-ACBF-2D598F686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0698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0049465-B1C0-4011-9420-C64B41488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488BEA6-7DE0-42D5-AA05-4AB7E9BB6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9721903-D23E-4DB9-A2CC-8AA8FD2B5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4469A47-25E7-4086-A1F6-E335E5E7A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7885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1BD3EE5-E922-43A9-AAE6-5BA3A0EA8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7E3AD86-6AAE-4AF1-8F79-A7368C779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F4165E1-293F-4A69-A674-D74FD0763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81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A56925-BC0C-422B-9D16-AF550508E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C689ED7-84E0-4999-9A54-767EABFEE8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2564315-F6B7-46B4-9061-D57226D8C3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5C81119-05B8-4644-89B4-1A8773678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11DADE5-4EDF-47A3-8E35-B6623CBED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69A7963-BDAF-4FED-BAAF-368412442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4910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525A41-FFBF-4B35-AA50-1A4E71CF9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4EE4D89-B506-4A3B-B301-9948A1894D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C22F897-BCC1-4485-9C70-F22D466CE0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B766DF3-D680-40F8-B1CC-EF0A081C7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175DB97-BE00-4888-B864-BACD48347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E5A1989-6548-418B-9B09-D6D9DD54D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3286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2761EF8-27E9-4356-B23E-F791343EEC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B399A5-D7C0-4195-BA40-021AEACD6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F53A575-74B4-48A6-9EDE-B5EB9A9F5D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4DB9B-3E3C-4D85-9A29-ACAB84954876}" type="datetimeFigureOut">
              <a:rPr lang="de-DE" smtClean="0"/>
              <a:t>23.1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C166551-228C-4F00-96CD-0583011A92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F84856-38DE-4496-AD72-1D105646A5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E2E3D7-1A09-4DC1-BC7C-78F139FB61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2451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image" Target="../media/image1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879E5C8B-70FE-40EC-B28E-370F2A2108A7}"/>
              </a:ext>
            </a:extLst>
          </p:cNvPr>
          <p:cNvSpPr txBox="1"/>
          <p:nvPr/>
        </p:nvSpPr>
        <p:spPr>
          <a:xfrm>
            <a:off x="0" y="6550223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1: 13 different sequences of </a:t>
            </a:r>
            <a:r>
              <a:rPr lang="en-US" sz="1400" b="1" i="1" dirty="0"/>
              <a:t>P. falciparum</a:t>
            </a:r>
            <a:r>
              <a:rPr lang="en-US" sz="1400" b="1" dirty="0"/>
              <a:t> EXP1 and two sequences of </a:t>
            </a:r>
            <a:r>
              <a:rPr lang="en-US" sz="1400" b="1" i="1" dirty="0"/>
              <a:t>P. vivax </a:t>
            </a:r>
            <a:r>
              <a:rPr lang="en-US" sz="1400" b="1" dirty="0"/>
              <a:t>EXP1.</a:t>
            </a:r>
            <a:endParaRPr lang="de-DE" sz="1400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986BF6BD-83C9-4A69-A1B7-8853343B4B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047" y="61952"/>
            <a:ext cx="10799906" cy="64882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8803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3FB47028-920F-4998-9CC4-5578688C7E7F}"/>
              </a:ext>
            </a:extLst>
          </p:cNvPr>
          <p:cNvSpPr txBox="1"/>
          <p:nvPr/>
        </p:nvSpPr>
        <p:spPr>
          <a:xfrm>
            <a:off x="0" y="6550223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2 A, B: </a:t>
            </a:r>
            <a:r>
              <a:rPr lang="en-US" sz="1400" b="1" i="1" dirty="0"/>
              <a:t>In silico </a:t>
            </a:r>
            <a:r>
              <a:rPr lang="en-US" sz="1400" b="1" dirty="0"/>
              <a:t>(A) and most likely (B) binding predictions for EXP1 peptides that elicited a CD4+ T cell response.</a:t>
            </a:r>
            <a:endParaRPr lang="de-DE" sz="1000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F4909A43-7933-43F2-A6A3-9F900C08FD4B}"/>
              </a:ext>
            </a:extLst>
          </p:cNvPr>
          <p:cNvSpPr txBox="1"/>
          <p:nvPr/>
        </p:nvSpPr>
        <p:spPr>
          <a:xfrm>
            <a:off x="-76200" y="55705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C1D9902F-CC83-492E-A0C4-54429DED08A5}"/>
              </a:ext>
            </a:extLst>
          </p:cNvPr>
          <p:cNvSpPr txBox="1"/>
          <p:nvPr/>
        </p:nvSpPr>
        <p:spPr>
          <a:xfrm>
            <a:off x="-76200" y="324530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E7188F8A-874A-497C-A368-1FE9470FE1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36032"/>
            <a:ext cx="12192000" cy="2105008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5B3189F9-C8F8-4DE8-8457-1E13ABD111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" y="3691730"/>
            <a:ext cx="6581774" cy="2140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7647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F457ABDF-7BEF-4968-A60B-BAF7126CAA10}"/>
              </a:ext>
            </a:extLst>
          </p:cNvPr>
          <p:cNvSpPr txBox="1"/>
          <p:nvPr/>
        </p:nvSpPr>
        <p:spPr>
          <a:xfrm>
            <a:off x="0" y="6550223"/>
            <a:ext cx="3655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upplementary figure 1: Epitope map of EXP1. </a:t>
            </a:r>
            <a:endParaRPr lang="de-DE" sz="1400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76E2483E-4FFD-4485-9E84-8C43E8FBDC0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303"/>
          <a:stretch/>
        </p:blipFill>
        <p:spPr>
          <a:xfrm>
            <a:off x="322729" y="37964"/>
            <a:ext cx="11546542" cy="65122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6243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Grafik 16" descr="Ein Bild, das Karte enthält.&#10;&#10;Automatisch generierte Beschreibung">
            <a:extLst>
              <a:ext uri="{FF2B5EF4-FFF2-40B4-BE49-F238E27FC236}">
                <a16:creationId xmlns:a16="http://schemas.microsoft.com/office/drawing/2014/main" id="{76FB685D-6807-4377-A21D-02D47140F91D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229" y="655760"/>
            <a:ext cx="9068586" cy="5395428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F6142591-3BE2-4740-8AD0-EF69B9017624}"/>
              </a:ext>
            </a:extLst>
          </p:cNvPr>
          <p:cNvSpPr txBox="1"/>
          <p:nvPr/>
        </p:nvSpPr>
        <p:spPr>
          <a:xfrm>
            <a:off x="2105437" y="3059662"/>
            <a:ext cx="1875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PC-Cy7: DUMP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9B91EB8B-0EAC-4D39-A038-F1EAA86D1D3F}"/>
              </a:ext>
            </a:extLst>
          </p:cNvPr>
          <p:cNvSpPr txBox="1"/>
          <p:nvPr/>
        </p:nvSpPr>
        <p:spPr>
          <a:xfrm>
            <a:off x="5735997" y="3059668"/>
            <a:ext cx="720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SC-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9449E898-7A49-4C6D-8995-E5E336A4BC92}"/>
              </a:ext>
            </a:extLst>
          </p:cNvPr>
          <p:cNvSpPr txBox="1"/>
          <p:nvPr/>
        </p:nvSpPr>
        <p:spPr>
          <a:xfrm>
            <a:off x="8964456" y="3059668"/>
            <a:ext cx="720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SC-A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CEEFB77-1BD7-46D3-8B9E-A3976CFBD4C2}"/>
              </a:ext>
            </a:extLst>
          </p:cNvPr>
          <p:cNvSpPr txBox="1"/>
          <p:nvPr/>
        </p:nvSpPr>
        <p:spPr>
          <a:xfrm rot="16200000">
            <a:off x="1040362" y="1665231"/>
            <a:ext cx="720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SC-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F34CB5C9-9093-4E6A-840D-285FA7E0EA2F}"/>
              </a:ext>
            </a:extLst>
          </p:cNvPr>
          <p:cNvSpPr txBox="1"/>
          <p:nvPr/>
        </p:nvSpPr>
        <p:spPr>
          <a:xfrm rot="16200000">
            <a:off x="4121775" y="1659621"/>
            <a:ext cx="73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SC-H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5267431-5592-4587-8A35-23EF48B13BD4}"/>
              </a:ext>
            </a:extLst>
          </p:cNvPr>
          <p:cNvSpPr txBox="1"/>
          <p:nvPr/>
        </p:nvSpPr>
        <p:spPr>
          <a:xfrm rot="16200000">
            <a:off x="2615554" y="4555424"/>
            <a:ext cx="720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SC-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06938372-3D6A-4A7C-84B8-A0A453B3E214}"/>
              </a:ext>
            </a:extLst>
          </p:cNvPr>
          <p:cNvSpPr txBox="1"/>
          <p:nvPr/>
        </p:nvSpPr>
        <p:spPr>
          <a:xfrm rot="16200000">
            <a:off x="7258844" y="166686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SC-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DF5309C-84BD-4108-A8F1-7B9F29C1F0C1}"/>
              </a:ext>
            </a:extLst>
          </p:cNvPr>
          <p:cNvSpPr txBox="1"/>
          <p:nvPr/>
        </p:nvSpPr>
        <p:spPr>
          <a:xfrm rot="16200000">
            <a:off x="4851340" y="4387710"/>
            <a:ext cx="266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rilliant Violet 786: </a:t>
            </a:r>
            <a:r>
              <a:rPr lang="de-DE" dirty="0"/>
              <a:t>CD8+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973BE3B8-DD8B-4FDA-A0D4-E0B071F615C4}"/>
              </a:ext>
            </a:extLst>
          </p:cNvPr>
          <p:cNvSpPr txBox="1"/>
          <p:nvPr/>
        </p:nvSpPr>
        <p:spPr>
          <a:xfrm>
            <a:off x="6620294" y="5968282"/>
            <a:ext cx="2000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rCP-Cy5.5: </a:t>
            </a:r>
            <a:r>
              <a:rPr lang="de-DE" dirty="0"/>
              <a:t>CD4+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7C8C7FB4-D4EE-4783-8E09-87D9C312E213}"/>
              </a:ext>
            </a:extLst>
          </p:cNvPr>
          <p:cNvSpPr txBox="1"/>
          <p:nvPr/>
        </p:nvSpPr>
        <p:spPr>
          <a:xfrm>
            <a:off x="3441013" y="5970508"/>
            <a:ext cx="246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AlexaFluor</a:t>
            </a:r>
            <a:r>
              <a:rPr lang="en-US" dirty="0"/>
              <a:t> 700: </a:t>
            </a:r>
            <a:r>
              <a:rPr lang="de-DE" dirty="0"/>
              <a:t>CD3+</a:t>
            </a:r>
          </a:p>
        </p:txBody>
      </p: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id="{5008033E-77B3-490C-9632-89F6E4152170}"/>
              </a:ext>
            </a:extLst>
          </p:cNvPr>
          <p:cNvCxnSpPr>
            <a:cxnSpLocks/>
          </p:cNvCxnSpPr>
          <p:nvPr/>
        </p:nvCxnSpPr>
        <p:spPr>
          <a:xfrm>
            <a:off x="2328333" y="1312333"/>
            <a:ext cx="2243667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AA28C3EF-AB35-4D9E-BD06-F501B2869022}"/>
              </a:ext>
            </a:extLst>
          </p:cNvPr>
          <p:cNvCxnSpPr>
            <a:cxnSpLocks/>
          </p:cNvCxnSpPr>
          <p:nvPr/>
        </p:nvCxnSpPr>
        <p:spPr>
          <a:xfrm>
            <a:off x="6797614" y="1312333"/>
            <a:ext cx="940919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E1E8ACF0-03BF-4D6F-91D4-CA11D1A63CC7}"/>
              </a:ext>
            </a:extLst>
          </p:cNvPr>
          <p:cNvCxnSpPr>
            <a:cxnSpLocks/>
          </p:cNvCxnSpPr>
          <p:nvPr/>
        </p:nvCxnSpPr>
        <p:spPr>
          <a:xfrm flipH="1">
            <a:off x="5486401" y="2663214"/>
            <a:ext cx="3478055" cy="960519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315DE1F9-E720-42A4-AC71-DDE8FECAB637}"/>
              </a:ext>
            </a:extLst>
          </p:cNvPr>
          <p:cNvCxnSpPr>
            <a:cxnSpLocks/>
          </p:cNvCxnSpPr>
          <p:nvPr/>
        </p:nvCxnSpPr>
        <p:spPr>
          <a:xfrm>
            <a:off x="5088467" y="4380088"/>
            <a:ext cx="909055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feld 39">
            <a:extLst>
              <a:ext uri="{FF2B5EF4-FFF2-40B4-BE49-F238E27FC236}">
                <a16:creationId xmlns:a16="http://schemas.microsoft.com/office/drawing/2014/main" id="{7B82B27E-A28D-4E8F-A62D-69723F079F21}"/>
              </a:ext>
            </a:extLst>
          </p:cNvPr>
          <p:cNvSpPr txBox="1"/>
          <p:nvPr/>
        </p:nvSpPr>
        <p:spPr>
          <a:xfrm>
            <a:off x="0" y="6550223"/>
            <a:ext cx="114408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: Exemplary gating strategy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2489316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D608F6DD-7068-42CB-832A-99DE985C0088}"/>
              </a:ext>
            </a:extLst>
          </p:cNvPr>
          <p:cNvSpPr txBox="1"/>
          <p:nvPr/>
        </p:nvSpPr>
        <p:spPr>
          <a:xfrm>
            <a:off x="0" y="6550223"/>
            <a:ext cx="77074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Supplementary </a:t>
            </a:r>
            <a:r>
              <a:rPr lang="de-DE" sz="1400" b="1" dirty="0" err="1"/>
              <a:t>figure</a:t>
            </a:r>
            <a:r>
              <a:rPr lang="de-DE" sz="1400" b="1" dirty="0"/>
              <a:t> 3: Countries </a:t>
            </a:r>
            <a:r>
              <a:rPr lang="de-DE" sz="1400" b="1" dirty="0" err="1"/>
              <a:t>that</a:t>
            </a:r>
            <a:r>
              <a:rPr lang="de-DE" sz="1400" b="1" dirty="0"/>
              <a:t> </a:t>
            </a:r>
            <a:r>
              <a:rPr lang="de-DE" sz="1400" b="1" dirty="0" err="1"/>
              <a:t>were</a:t>
            </a:r>
            <a:r>
              <a:rPr lang="de-DE" sz="1400" b="1" dirty="0"/>
              <a:t> </a:t>
            </a:r>
            <a:r>
              <a:rPr lang="de-DE" sz="1400" b="1" dirty="0" err="1"/>
              <a:t>visited</a:t>
            </a:r>
            <a:r>
              <a:rPr lang="de-DE" sz="1400" b="1" dirty="0"/>
              <a:t> </a:t>
            </a:r>
            <a:r>
              <a:rPr lang="de-DE" sz="1400" b="1" dirty="0" err="1"/>
              <a:t>by</a:t>
            </a:r>
            <a:r>
              <a:rPr lang="de-DE" sz="1400" b="1" dirty="0"/>
              <a:t> 41 </a:t>
            </a:r>
            <a:r>
              <a:rPr lang="de-DE" sz="1400" b="1" dirty="0" err="1"/>
              <a:t>malaria</a:t>
            </a:r>
            <a:r>
              <a:rPr lang="de-DE" sz="1400" b="1" dirty="0"/>
              <a:t> </a:t>
            </a:r>
            <a:r>
              <a:rPr lang="de-DE" sz="1400" b="1" dirty="0" err="1"/>
              <a:t>patients</a:t>
            </a:r>
            <a:r>
              <a:rPr lang="de-DE" sz="1400" b="1" dirty="0"/>
              <a:t> </a:t>
            </a:r>
            <a:r>
              <a:rPr lang="de-DE" sz="1400" b="1" dirty="0" err="1"/>
              <a:t>are</a:t>
            </a:r>
            <a:r>
              <a:rPr lang="de-DE" sz="1400" b="1" dirty="0"/>
              <a:t> </a:t>
            </a:r>
            <a:r>
              <a:rPr lang="de-DE" sz="1400" b="1" dirty="0" err="1"/>
              <a:t>marked</a:t>
            </a:r>
            <a:r>
              <a:rPr lang="de-DE" sz="1400" b="1" dirty="0"/>
              <a:t> </a:t>
            </a:r>
            <a:r>
              <a:rPr lang="de-DE" sz="1400" b="1" dirty="0" err="1"/>
              <a:t>by</a:t>
            </a:r>
            <a:r>
              <a:rPr lang="de-DE" sz="1400" b="1" dirty="0"/>
              <a:t> a </a:t>
            </a:r>
            <a:r>
              <a:rPr lang="de-DE" sz="1400" b="1" dirty="0" err="1"/>
              <a:t>black</a:t>
            </a:r>
            <a:r>
              <a:rPr lang="de-DE" sz="1400" b="1" dirty="0"/>
              <a:t> </a:t>
            </a:r>
            <a:r>
              <a:rPr lang="de-DE" sz="1400" b="1" dirty="0" err="1"/>
              <a:t>dot</a:t>
            </a:r>
            <a:r>
              <a:rPr lang="de-DE" sz="1400" b="1" dirty="0"/>
              <a:t>.</a:t>
            </a:r>
          </a:p>
        </p:txBody>
      </p:sp>
      <p:pic>
        <p:nvPicPr>
          <p:cNvPr id="4" name="Grafik 3" descr="Ein Bild, das Text, Karte enthält.&#10;&#10;Automatisch generierte Beschreibung">
            <a:extLst>
              <a:ext uri="{FF2B5EF4-FFF2-40B4-BE49-F238E27FC236}">
                <a16:creationId xmlns:a16="http://schemas.microsoft.com/office/drawing/2014/main" id="{8B40061F-419B-4F0D-AFED-20739B77737B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5798" y="177030"/>
            <a:ext cx="6060403" cy="6503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49963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ieren 21">
            <a:extLst>
              <a:ext uri="{FF2B5EF4-FFF2-40B4-BE49-F238E27FC236}">
                <a16:creationId xmlns:a16="http://schemas.microsoft.com/office/drawing/2014/main" id="{4960FCD2-70B5-4CD0-BF24-89F9064D1DFC}"/>
              </a:ext>
            </a:extLst>
          </p:cNvPr>
          <p:cNvGrpSpPr/>
          <p:nvPr/>
        </p:nvGrpSpPr>
        <p:grpSpPr>
          <a:xfrm>
            <a:off x="353161" y="3769"/>
            <a:ext cx="4790339" cy="4563609"/>
            <a:chOff x="64424" y="610562"/>
            <a:chExt cx="4790339" cy="4556243"/>
          </a:xfrm>
        </p:grpSpPr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id="{E2E07F6B-1C0D-4AE3-80DB-5E2746F0D771}"/>
                </a:ext>
              </a:extLst>
            </p:cNvPr>
            <p:cNvGrpSpPr/>
            <p:nvPr/>
          </p:nvGrpSpPr>
          <p:grpSpPr>
            <a:xfrm>
              <a:off x="67205" y="2769475"/>
              <a:ext cx="4787558" cy="2397330"/>
              <a:chOff x="69663" y="3316610"/>
              <a:chExt cx="6176925" cy="3251046"/>
            </a:xfrm>
          </p:grpSpPr>
          <p:cxnSp>
            <p:nvCxnSpPr>
              <p:cNvPr id="9" name="Gerade Verbindung mit Pfeil 8">
                <a:extLst>
                  <a:ext uri="{FF2B5EF4-FFF2-40B4-BE49-F238E27FC236}">
                    <a16:creationId xmlns:a16="http://schemas.microsoft.com/office/drawing/2014/main" id="{889DE352-1747-4A98-A92E-E6CC095959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02166" y="3316610"/>
                <a:ext cx="1" cy="2865136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Gerade Verbindung mit Pfeil 9">
                <a:extLst>
                  <a:ext uri="{FF2B5EF4-FFF2-40B4-BE49-F238E27FC236}">
                    <a16:creationId xmlns:a16="http://schemas.microsoft.com/office/drawing/2014/main" id="{26F2267C-8397-4675-A428-183C5A7754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2166" y="6187670"/>
                <a:ext cx="5744422" cy="25075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feld 10">
                <a:extLst>
                  <a:ext uri="{FF2B5EF4-FFF2-40B4-BE49-F238E27FC236}">
                    <a16:creationId xmlns:a16="http://schemas.microsoft.com/office/drawing/2014/main" id="{D09C5A2F-BE54-4A36-AC58-B036C180734C}"/>
                  </a:ext>
                </a:extLst>
              </p:cNvPr>
              <p:cNvSpPr txBox="1"/>
              <p:nvPr/>
            </p:nvSpPr>
            <p:spPr>
              <a:xfrm rot="16200000">
                <a:off x="-111578" y="4498115"/>
                <a:ext cx="765825" cy="403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D8+</a:t>
                </a:r>
              </a:p>
            </p:txBody>
          </p: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ADEEAD82-24E3-4CE6-B3EE-B0DB3297BA5A}"/>
                  </a:ext>
                </a:extLst>
              </p:cNvPr>
              <p:cNvSpPr txBox="1"/>
              <p:nvPr/>
            </p:nvSpPr>
            <p:spPr>
              <a:xfrm>
                <a:off x="2976916" y="6153658"/>
                <a:ext cx="838900" cy="41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IFN</a:t>
                </a:r>
                <a:r>
                  <a:rPr lang="en-US" dirty="0"/>
                  <a:t>γ</a:t>
                </a:r>
                <a:r>
                  <a:rPr lang="de-DE" dirty="0"/>
                  <a:t> +</a:t>
                </a:r>
              </a:p>
            </p:txBody>
          </p:sp>
          <p:pic>
            <p:nvPicPr>
              <p:cNvPr id="13" name="Grafik 12">
                <a:extLst>
                  <a:ext uri="{FF2B5EF4-FFF2-40B4-BE49-F238E27FC236}">
                    <a16:creationId xmlns:a16="http://schemas.microsoft.com/office/drawing/2014/main" id="{5A064B12-845D-42B1-86EA-D6C07C847D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</a:blip>
              <a:srcRect l="9473" t="2712" r="-758" b="7145"/>
              <a:stretch/>
            </p:blipFill>
            <p:spPr>
              <a:xfrm>
                <a:off x="647698" y="3349788"/>
                <a:ext cx="2777554" cy="2700000"/>
              </a:xfrm>
              <a:prstGeom prst="rect">
                <a:avLst/>
              </a:prstGeom>
            </p:spPr>
          </p:pic>
          <p:pic>
            <p:nvPicPr>
              <p:cNvPr id="14" name="Grafik 13">
                <a:extLst>
                  <a:ext uri="{FF2B5EF4-FFF2-40B4-BE49-F238E27FC236}">
                    <a16:creationId xmlns:a16="http://schemas.microsoft.com/office/drawing/2014/main" id="{B591B059-B972-460E-BF64-83E8F177E7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9442" t="2740" r="-670" b="7171"/>
              <a:stretch/>
            </p:blipFill>
            <p:spPr>
              <a:xfrm>
                <a:off x="3348842" y="3349788"/>
                <a:ext cx="2777554" cy="2700000"/>
              </a:xfrm>
              <a:prstGeom prst="rect">
                <a:avLst/>
              </a:prstGeom>
            </p:spPr>
          </p:pic>
        </p:grpSp>
        <p:sp>
          <p:nvSpPr>
            <p:cNvPr id="15" name="Rechteck 14">
              <a:extLst>
                <a:ext uri="{FF2B5EF4-FFF2-40B4-BE49-F238E27FC236}">
                  <a16:creationId xmlns:a16="http://schemas.microsoft.com/office/drawing/2014/main" id="{DE27C714-BFEF-485B-96E2-7E8EF05AB7AB}"/>
                </a:ext>
              </a:extLst>
            </p:cNvPr>
            <p:cNvSpPr/>
            <p:nvPr/>
          </p:nvSpPr>
          <p:spPr>
            <a:xfrm>
              <a:off x="378130" y="4859373"/>
              <a:ext cx="45719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E8A9E557-B3FB-4E74-9A0B-7E8409500469}"/>
                </a:ext>
              </a:extLst>
            </p:cNvPr>
            <p:cNvSpPr txBox="1"/>
            <p:nvPr/>
          </p:nvSpPr>
          <p:spPr>
            <a:xfrm>
              <a:off x="64424" y="610562"/>
              <a:ext cx="3137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400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A</a:t>
              </a:r>
              <a:endParaRPr lang="de-DE" sz="2400" b="1" dirty="0">
                <a:solidFill>
                  <a:srgbClr val="0070C0"/>
                </a:solidFill>
              </a:endParaRPr>
            </a:p>
          </p:txBody>
        </p:sp>
      </p:grpSp>
      <p:sp>
        <p:nvSpPr>
          <p:cNvPr id="17" name="Textfeld 16">
            <a:extLst>
              <a:ext uri="{FF2B5EF4-FFF2-40B4-BE49-F238E27FC236}">
                <a16:creationId xmlns:a16="http://schemas.microsoft.com/office/drawing/2014/main" id="{50329FC2-1DE2-46EB-AB84-9716E36FD665}"/>
              </a:ext>
            </a:extLst>
          </p:cNvPr>
          <p:cNvSpPr txBox="1"/>
          <p:nvPr/>
        </p:nvSpPr>
        <p:spPr>
          <a:xfrm>
            <a:off x="5038972" y="0"/>
            <a:ext cx="300481" cy="4661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de-DE" sz="2400" b="1" dirty="0">
              <a:solidFill>
                <a:srgbClr val="0070C0"/>
              </a:solidFill>
            </a:endParaRPr>
          </a:p>
        </p:txBody>
      </p:sp>
      <p:pic>
        <p:nvPicPr>
          <p:cNvPr id="26" name="Grafik 25">
            <a:extLst>
              <a:ext uri="{FF2B5EF4-FFF2-40B4-BE49-F238E27FC236}">
                <a16:creationId xmlns:a16="http://schemas.microsoft.com/office/drawing/2014/main" id="{05181D63-F618-4DD2-A392-B2CB2F1576A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009"/>
          <a:stretch/>
        </p:blipFill>
        <p:spPr>
          <a:xfrm>
            <a:off x="6141718" y="0"/>
            <a:ext cx="5363951" cy="6334265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E9C053E8-48AA-4426-A74B-55BEF8E5F299}"/>
              </a:ext>
            </a:extLst>
          </p:cNvPr>
          <p:cNvSpPr txBox="1"/>
          <p:nvPr/>
        </p:nvSpPr>
        <p:spPr>
          <a:xfrm>
            <a:off x="0" y="6550223"/>
            <a:ext cx="12049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/>
              <a:t>Supplementary</a:t>
            </a:r>
            <a:r>
              <a:rPr lang="de-DE" sz="1400" b="1" dirty="0"/>
              <a:t> </a:t>
            </a:r>
            <a:r>
              <a:rPr lang="de-DE" sz="1400" b="1" dirty="0" err="1"/>
              <a:t>figure</a:t>
            </a:r>
            <a:r>
              <a:rPr lang="de-DE" sz="1400" b="1" dirty="0"/>
              <a:t> 4 A, B: </a:t>
            </a:r>
            <a:r>
              <a:rPr lang="en-US" sz="1400" b="1" dirty="0"/>
              <a:t>Exemplary ICS dot blot of a </a:t>
            </a:r>
            <a:r>
              <a:rPr lang="en-US" sz="1400" b="1" i="1" dirty="0"/>
              <a:t>P. falciparum</a:t>
            </a:r>
            <a:r>
              <a:rPr lang="en-US" sz="1400" b="1" dirty="0"/>
              <a:t>-specific CD8+ T cell response of HH-45 against EXP1-P15.</a:t>
            </a:r>
            <a:endParaRPr lang="de-DE" sz="1400" b="1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A7192225-A948-4712-BDC4-0E8B046EF26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361"/>
          <a:stretch/>
        </p:blipFill>
        <p:spPr>
          <a:xfrm>
            <a:off x="5545152" y="6334265"/>
            <a:ext cx="4276725" cy="172666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6F12EF22-5951-4223-AA1E-CB1F59C923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55427" y="-1"/>
            <a:ext cx="607713" cy="6334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39872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6FE5872-D526-4F91-A87A-6D463073B6A5}"/>
              </a:ext>
            </a:extLst>
          </p:cNvPr>
          <p:cNvSpPr txBox="1"/>
          <p:nvPr/>
        </p:nvSpPr>
        <p:spPr>
          <a:xfrm>
            <a:off x="0" y="6550223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5 A, B: Breadth of the </a:t>
            </a:r>
            <a:r>
              <a:rPr lang="en-US" sz="1400" b="1" i="1" dirty="0"/>
              <a:t>P. falciparum</a:t>
            </a:r>
            <a:r>
              <a:rPr lang="en-US" sz="1400" b="1" dirty="0"/>
              <a:t>-specific T cell response in correlation with age [years] and sex.</a:t>
            </a:r>
            <a:endParaRPr lang="de-DE" sz="1400" dirty="0"/>
          </a:p>
        </p:txBody>
      </p:sp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1D527405-48C9-4C10-A48E-66F667CDEB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4195865"/>
              </p:ext>
            </p:extLst>
          </p:nvPr>
        </p:nvGraphicFramePr>
        <p:xfrm>
          <a:off x="523582" y="1261065"/>
          <a:ext cx="4847853" cy="40363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9" name="Prism 7" r:id="rId3" imgW="3594875" imgH="2992880" progId="Prism7.Document">
                  <p:embed/>
                </p:oleObj>
              </mc:Choice>
              <mc:Fallback>
                <p:oleObj name="Prism 7" r:id="rId3" imgW="3594875" imgH="2992880" progId="Prism7.Document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3582" y="1261065"/>
                        <a:ext cx="4847853" cy="40363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Grafik 11">
            <a:extLst>
              <a:ext uri="{FF2B5EF4-FFF2-40B4-BE49-F238E27FC236}">
                <a16:creationId xmlns:a16="http://schemas.microsoft.com/office/drawing/2014/main" id="{BC37691A-E42A-4B62-B01D-CBE247096E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20566" y="1261065"/>
            <a:ext cx="4507833" cy="3724231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C3AAB9C7-1A2C-4AD6-B2D4-6EB6A067C46E}"/>
              </a:ext>
            </a:extLst>
          </p:cNvPr>
          <p:cNvSpPr txBox="1"/>
          <p:nvPr/>
        </p:nvSpPr>
        <p:spPr>
          <a:xfrm>
            <a:off x="523582" y="79939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819B2B67-8CDA-461F-BE4F-D311452D99EB}"/>
              </a:ext>
            </a:extLst>
          </p:cNvPr>
          <p:cNvSpPr txBox="1"/>
          <p:nvPr/>
        </p:nvSpPr>
        <p:spPr>
          <a:xfrm>
            <a:off x="6828675" y="7993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176909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1B6081D-D3E8-4209-B85B-EB1C655A627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/>
        </p:nvCxnSpPr>
        <p:spPr>
          <a:xfrm>
            <a:off x="6091214" y="1111170"/>
            <a:ext cx="11040" cy="4645103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8CA55E4-1295-45C8-BA05-5A9E705B749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/>
        </p:nvCxnSpPr>
        <p:spPr>
          <a:xfrm>
            <a:off x="1403027" y="3428998"/>
            <a:ext cx="4188904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8C5794E-A9A1-4A23-AF68-C79A7822334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/>
        </p:nvCxnSpPr>
        <p:spPr>
          <a:xfrm>
            <a:off x="6610334" y="3428998"/>
            <a:ext cx="4188904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>
            <a:extLst>
              <a:ext uri="{FF2B5EF4-FFF2-40B4-BE49-F238E27FC236}">
                <a16:creationId xmlns:a16="http://schemas.microsoft.com/office/drawing/2014/main" id="{0210BBB9-9A88-4867-88E3-61414BC0481A}"/>
              </a:ext>
            </a:extLst>
          </p:cNvPr>
          <p:cNvSpPr txBox="1"/>
          <p:nvPr/>
        </p:nvSpPr>
        <p:spPr>
          <a:xfrm>
            <a:off x="1403027" y="37100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A36B706-496F-4961-9723-CCB9A9019332}"/>
              </a:ext>
            </a:extLst>
          </p:cNvPr>
          <p:cNvSpPr txBox="1"/>
          <p:nvPr/>
        </p:nvSpPr>
        <p:spPr>
          <a:xfrm>
            <a:off x="6640323" y="37100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D2714074-9F85-4CC9-860D-9D9FDC0C7764}"/>
              </a:ext>
            </a:extLst>
          </p:cNvPr>
          <p:cNvSpPr txBox="1"/>
          <p:nvPr/>
        </p:nvSpPr>
        <p:spPr>
          <a:xfrm>
            <a:off x="1425469" y="377052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C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1C0C72F5-9482-45C4-AED7-2E1B93625177}"/>
              </a:ext>
            </a:extLst>
          </p:cNvPr>
          <p:cNvSpPr txBox="1"/>
          <p:nvPr/>
        </p:nvSpPr>
        <p:spPr>
          <a:xfrm>
            <a:off x="6675886" y="3816689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D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30696D2A-9CB8-403A-8049-7B12CF7194F9}"/>
              </a:ext>
            </a:extLst>
          </p:cNvPr>
          <p:cNvSpPr txBox="1"/>
          <p:nvPr/>
        </p:nvSpPr>
        <p:spPr>
          <a:xfrm>
            <a:off x="0" y="6540960"/>
            <a:ext cx="12235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6 A, B, C, D: Breadth of the </a:t>
            </a:r>
            <a:r>
              <a:rPr lang="en-US" sz="1400" b="1" i="1" dirty="0"/>
              <a:t>P. falciparum</a:t>
            </a:r>
            <a:r>
              <a:rPr lang="en-US" sz="1400" b="1" dirty="0"/>
              <a:t>-specific T cell response in correlation with patient characteristics.</a:t>
            </a:r>
            <a:endParaRPr lang="de-DE" sz="1400" dirty="0"/>
          </a:p>
        </p:txBody>
      </p:sp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49E53FC0-ABAF-4A72-849C-F65F03F352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1663419"/>
              </p:ext>
            </p:extLst>
          </p:nvPr>
        </p:nvGraphicFramePr>
        <p:xfrm>
          <a:off x="7100588" y="3664308"/>
          <a:ext cx="2969731" cy="3030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5" name="Prism 7" r:id="rId3" imgW="3334136" imgH="3401655" progId="Prism7.Document">
                  <p:embed/>
                </p:oleObj>
              </mc:Choice>
              <mc:Fallback>
                <p:oleObj name="Prism 7" r:id="rId3" imgW="3334136" imgH="3401655" progId="Prism7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6FC7F71F-7598-4C5E-8581-CA35E6D879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00588" y="3664308"/>
                        <a:ext cx="2969731" cy="30305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" name="Grafik 21">
            <a:extLst>
              <a:ext uri="{FF2B5EF4-FFF2-40B4-BE49-F238E27FC236}">
                <a16:creationId xmlns:a16="http://schemas.microsoft.com/office/drawing/2014/main" id="{09ADDD8F-7910-4846-88DB-AC3D1C2719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6450" y="564237"/>
            <a:ext cx="3389623" cy="2846757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69EFC5C3-545C-4B57-B015-5C48CC53FF8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73030" y="564237"/>
            <a:ext cx="3292520" cy="2907174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F335B9E6-94AB-420B-841E-92DEA60B24C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29341" y="3664308"/>
            <a:ext cx="2906486" cy="3030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01480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feld 22">
            <a:extLst>
              <a:ext uri="{FF2B5EF4-FFF2-40B4-BE49-F238E27FC236}">
                <a16:creationId xmlns:a16="http://schemas.microsoft.com/office/drawing/2014/main" id="{49C3D94F-9D75-47D0-9849-2F57D68DD275}"/>
              </a:ext>
            </a:extLst>
          </p:cNvPr>
          <p:cNvSpPr txBox="1"/>
          <p:nvPr/>
        </p:nvSpPr>
        <p:spPr>
          <a:xfrm>
            <a:off x="0" y="6550223"/>
            <a:ext cx="114408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7: Restriction assay for EXP1-P15 with PBMCs of HH-03 (DRB1*04:05P,*15:02P, DQB1*04:02P, *05:02P).</a:t>
            </a:r>
            <a:endParaRPr lang="de-DE" sz="1400" dirty="0"/>
          </a:p>
        </p:txBody>
      </p:sp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F1FF98F8-0F46-479A-8519-B99AB3E4FF81}"/>
              </a:ext>
            </a:extLst>
          </p:cNvPr>
          <p:cNvGrpSpPr/>
          <p:nvPr/>
        </p:nvGrpSpPr>
        <p:grpSpPr>
          <a:xfrm>
            <a:off x="2723223" y="972347"/>
            <a:ext cx="5753138" cy="5329561"/>
            <a:chOff x="3062287" y="802198"/>
            <a:chExt cx="4856517" cy="4642798"/>
          </a:xfrm>
        </p:grpSpPr>
        <p:grpSp>
          <p:nvGrpSpPr>
            <p:cNvPr id="25" name="Gruppieren 24">
              <a:extLst>
                <a:ext uri="{FF2B5EF4-FFF2-40B4-BE49-F238E27FC236}">
                  <a16:creationId xmlns:a16="http://schemas.microsoft.com/office/drawing/2014/main" id="{74908267-5EEE-4A1B-969D-788E42168CD2}"/>
                </a:ext>
              </a:extLst>
            </p:cNvPr>
            <p:cNvGrpSpPr/>
            <p:nvPr/>
          </p:nvGrpSpPr>
          <p:grpSpPr>
            <a:xfrm>
              <a:off x="3062287" y="802198"/>
              <a:ext cx="4856517" cy="4642798"/>
              <a:chOff x="3206205" y="1890769"/>
              <a:chExt cx="4856517" cy="4642798"/>
            </a:xfrm>
          </p:grpSpPr>
          <p:grpSp>
            <p:nvGrpSpPr>
              <p:cNvPr id="20" name="Gruppieren 19">
                <a:extLst>
                  <a:ext uri="{FF2B5EF4-FFF2-40B4-BE49-F238E27FC236}">
                    <a16:creationId xmlns:a16="http://schemas.microsoft.com/office/drawing/2014/main" id="{9CDD741F-27FA-4847-BD68-C6F843395FF9}"/>
                  </a:ext>
                </a:extLst>
              </p:cNvPr>
              <p:cNvGrpSpPr/>
              <p:nvPr/>
            </p:nvGrpSpPr>
            <p:grpSpPr>
              <a:xfrm>
                <a:off x="3558310" y="1890769"/>
                <a:ext cx="4504412" cy="4337021"/>
                <a:chOff x="5236274" y="1966572"/>
                <a:chExt cx="4504412" cy="4337021"/>
              </a:xfrm>
            </p:grpSpPr>
            <p:grpSp>
              <p:nvGrpSpPr>
                <p:cNvPr id="15" name="Gruppieren 14">
                  <a:extLst>
                    <a:ext uri="{FF2B5EF4-FFF2-40B4-BE49-F238E27FC236}">
                      <a16:creationId xmlns:a16="http://schemas.microsoft.com/office/drawing/2014/main" id="{BF9FC459-8356-4D22-958B-0F1B5E79BF50}"/>
                    </a:ext>
                  </a:extLst>
                </p:cNvPr>
                <p:cNvGrpSpPr/>
                <p:nvPr/>
              </p:nvGrpSpPr>
              <p:grpSpPr>
                <a:xfrm>
                  <a:off x="5469646" y="1966572"/>
                  <a:ext cx="4271040" cy="455798"/>
                  <a:chOff x="4342475" y="2038443"/>
                  <a:chExt cx="4475985" cy="482641"/>
                </a:xfrm>
              </p:grpSpPr>
              <p:sp>
                <p:nvSpPr>
                  <p:cNvPr id="5" name="Textfeld 4">
                    <a:extLst>
                      <a:ext uri="{FF2B5EF4-FFF2-40B4-BE49-F238E27FC236}">
                        <a16:creationId xmlns:a16="http://schemas.microsoft.com/office/drawing/2014/main" id="{35AD9A4C-6A64-415A-B5D4-39F4192D64DA}"/>
                      </a:ext>
                    </a:extLst>
                  </p:cNvPr>
                  <p:cNvSpPr txBox="1"/>
                  <p:nvPr/>
                </p:nvSpPr>
                <p:spPr>
                  <a:xfrm>
                    <a:off x="4342475" y="2038443"/>
                    <a:ext cx="2167155" cy="48264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400" dirty="0" err="1"/>
                      <a:t>Donor</a:t>
                    </a:r>
                    <a:r>
                      <a:rPr lang="de-DE" sz="1400" dirty="0"/>
                      <a:t> 1: </a:t>
                    </a:r>
                    <a:r>
                      <a:rPr lang="de-DE" sz="1400" b="1" dirty="0"/>
                      <a:t>DRB1</a:t>
                    </a:r>
                    <a:r>
                      <a:rPr lang="en-US" sz="1400" b="1" dirty="0"/>
                      <a:t>*15:02</a:t>
                    </a:r>
                    <a:r>
                      <a:rPr lang="en-US" sz="1400" dirty="0"/>
                      <a:t>, *11:01; </a:t>
                    </a:r>
                  </a:p>
                  <a:p>
                    <a:r>
                      <a:rPr lang="en-US" sz="1400" dirty="0"/>
                      <a:t>          DQB1*03:01P, *06:01P</a:t>
                    </a:r>
                    <a:r>
                      <a:rPr lang="de-DE" sz="1400" dirty="0"/>
                      <a:t> </a:t>
                    </a:r>
                  </a:p>
                </p:txBody>
              </p:sp>
              <p:sp>
                <p:nvSpPr>
                  <p:cNvPr id="7" name="Textfeld 6">
                    <a:extLst>
                      <a:ext uri="{FF2B5EF4-FFF2-40B4-BE49-F238E27FC236}">
                        <a16:creationId xmlns:a16="http://schemas.microsoft.com/office/drawing/2014/main" id="{FBC47C21-46E7-46D3-BF0C-CB7D123E056E}"/>
                      </a:ext>
                    </a:extLst>
                  </p:cNvPr>
                  <p:cNvSpPr txBox="1"/>
                  <p:nvPr/>
                </p:nvSpPr>
                <p:spPr>
                  <a:xfrm>
                    <a:off x="6531221" y="2038443"/>
                    <a:ext cx="2287239" cy="48264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400" dirty="0" err="1"/>
                      <a:t>Donor</a:t>
                    </a:r>
                    <a:r>
                      <a:rPr lang="de-DE" sz="1400" dirty="0"/>
                      <a:t> 2: </a:t>
                    </a:r>
                    <a:r>
                      <a:rPr lang="de-DE" sz="1400" b="1" dirty="0"/>
                      <a:t>DRB1</a:t>
                    </a:r>
                    <a:r>
                      <a:rPr lang="en-US" sz="1400" b="1" dirty="0"/>
                      <a:t>*04:01P,*04:04P</a:t>
                    </a:r>
                    <a:r>
                      <a:rPr lang="en-US" sz="1400" dirty="0"/>
                      <a:t>; </a:t>
                    </a:r>
                  </a:p>
                  <a:p>
                    <a:r>
                      <a:rPr lang="en-US" sz="1400" dirty="0"/>
                      <a:t>          DQB1*03:02P</a:t>
                    </a:r>
                    <a:endParaRPr lang="de-DE" sz="1400" dirty="0"/>
                  </a:p>
                </p:txBody>
              </p:sp>
            </p:grpSp>
            <p:cxnSp>
              <p:nvCxnSpPr>
                <p:cNvPr id="14" name="Gerade Verbindung mit Pfeil 13">
                  <a:extLst>
                    <a:ext uri="{FF2B5EF4-FFF2-40B4-BE49-F238E27FC236}">
                      <a16:creationId xmlns:a16="http://schemas.microsoft.com/office/drawing/2014/main" id="{A2E1791C-5813-4705-BA57-9E653B09EF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236274" y="1966573"/>
                  <a:ext cx="20674" cy="4337020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Gerade Verbindung mit Pfeil 16">
                  <a:extLst>
                    <a:ext uri="{FF2B5EF4-FFF2-40B4-BE49-F238E27FC236}">
                      <a16:creationId xmlns:a16="http://schemas.microsoft.com/office/drawing/2014/main" id="{E45DBC07-054D-4CCD-8CC0-B82BF0BE00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59979" y="6278563"/>
                  <a:ext cx="4373697" cy="0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" name="Textfeld 20">
                <a:extLst>
                  <a:ext uri="{FF2B5EF4-FFF2-40B4-BE49-F238E27FC236}">
                    <a16:creationId xmlns:a16="http://schemas.microsoft.com/office/drawing/2014/main" id="{D3D8CDAA-9064-4FD1-9D61-9204A45166F6}"/>
                  </a:ext>
                </a:extLst>
              </p:cNvPr>
              <p:cNvSpPr txBox="1"/>
              <p:nvPr/>
            </p:nvSpPr>
            <p:spPr>
              <a:xfrm>
                <a:off x="5443759" y="6227790"/>
                <a:ext cx="650207" cy="305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IFN</a:t>
                </a:r>
                <a:r>
                  <a:rPr lang="en-US" dirty="0"/>
                  <a:t>γ</a:t>
                </a:r>
                <a:r>
                  <a:rPr lang="de-DE" dirty="0"/>
                  <a:t> +</a:t>
                </a:r>
              </a:p>
            </p:txBody>
          </p:sp>
          <p:sp>
            <p:nvSpPr>
              <p:cNvPr id="22" name="Textfeld 21">
                <a:extLst>
                  <a:ext uri="{FF2B5EF4-FFF2-40B4-BE49-F238E27FC236}">
                    <a16:creationId xmlns:a16="http://schemas.microsoft.com/office/drawing/2014/main" id="{A3337E74-01CE-4641-97A3-27E880A805E3}"/>
                  </a:ext>
                </a:extLst>
              </p:cNvPr>
              <p:cNvSpPr txBox="1"/>
              <p:nvPr/>
            </p:nvSpPr>
            <p:spPr>
              <a:xfrm rot="16200000">
                <a:off x="3041146" y="3875925"/>
                <a:ext cx="639986" cy="309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D4 +</a:t>
                </a:r>
              </a:p>
            </p:txBody>
          </p:sp>
        </p:grpSp>
        <p:grpSp>
          <p:nvGrpSpPr>
            <p:cNvPr id="16" name="Gruppieren 15">
              <a:extLst>
                <a:ext uri="{FF2B5EF4-FFF2-40B4-BE49-F238E27FC236}">
                  <a16:creationId xmlns:a16="http://schemas.microsoft.com/office/drawing/2014/main" id="{48326ACD-9B79-418C-9C70-722A549FAB52}"/>
                </a:ext>
              </a:extLst>
            </p:cNvPr>
            <p:cNvGrpSpPr/>
            <p:nvPr/>
          </p:nvGrpSpPr>
          <p:grpSpPr>
            <a:xfrm>
              <a:off x="3647765" y="1153624"/>
              <a:ext cx="3958426" cy="3831907"/>
              <a:chOff x="3778962" y="637853"/>
              <a:chExt cx="5969737" cy="5886708"/>
            </a:xfrm>
          </p:grpSpPr>
          <p:pic>
            <p:nvPicPr>
              <p:cNvPr id="19" name="Grafik 18">
                <a:extLst>
                  <a:ext uri="{FF2B5EF4-FFF2-40B4-BE49-F238E27FC236}">
                    <a16:creationId xmlns:a16="http://schemas.microsoft.com/office/drawing/2014/main" id="{CD14A495-6F7C-4068-952B-FB6E5D1857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</a:blip>
              <a:srcRect l="7480" b="4343"/>
              <a:stretch/>
            </p:blipFill>
            <p:spPr>
              <a:xfrm>
                <a:off x="6928693" y="637853"/>
                <a:ext cx="2820006" cy="2870063"/>
              </a:xfrm>
              <a:prstGeom prst="rect">
                <a:avLst/>
              </a:prstGeom>
            </p:spPr>
          </p:pic>
          <p:pic>
            <p:nvPicPr>
              <p:cNvPr id="26" name="Grafik 25">
                <a:extLst>
                  <a:ext uri="{FF2B5EF4-FFF2-40B4-BE49-F238E27FC236}">
                    <a16:creationId xmlns:a16="http://schemas.microsoft.com/office/drawing/2014/main" id="{E9B72511-1050-4A48-ABFB-0A296E8BE8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8898" b="4343"/>
              <a:stretch/>
            </p:blipFill>
            <p:spPr>
              <a:xfrm>
                <a:off x="3822190" y="3654497"/>
                <a:ext cx="2776778" cy="2870064"/>
              </a:xfrm>
              <a:prstGeom prst="rect">
                <a:avLst/>
              </a:prstGeom>
            </p:spPr>
          </p:pic>
          <p:sp>
            <p:nvSpPr>
              <p:cNvPr id="27" name="Textfeld 26">
                <a:extLst>
                  <a:ext uri="{FF2B5EF4-FFF2-40B4-BE49-F238E27FC236}">
                    <a16:creationId xmlns:a16="http://schemas.microsoft.com/office/drawing/2014/main" id="{5F1D2ABA-AB86-42E8-A5B5-0A16F3CEA2D1}"/>
                  </a:ext>
                </a:extLst>
              </p:cNvPr>
              <p:cNvSpPr txBox="1"/>
              <p:nvPr/>
            </p:nvSpPr>
            <p:spPr>
              <a:xfrm>
                <a:off x="4500203" y="3429321"/>
                <a:ext cx="1739198" cy="4118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negative </a:t>
                </a:r>
                <a:r>
                  <a:rPr lang="de-DE" sz="1400" dirty="0" err="1"/>
                  <a:t>control</a:t>
                </a:r>
                <a:endParaRPr lang="de-DE" sz="1400" dirty="0"/>
              </a:p>
            </p:txBody>
          </p:sp>
          <p:pic>
            <p:nvPicPr>
              <p:cNvPr id="28" name="Grafik 27">
                <a:extLst>
                  <a:ext uri="{FF2B5EF4-FFF2-40B4-BE49-F238E27FC236}">
                    <a16:creationId xmlns:a16="http://schemas.microsoft.com/office/drawing/2014/main" id="{33B835AA-2FC7-4F0B-999E-2B80AF9F72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</a:blip>
              <a:srcRect l="7480" b="4343"/>
              <a:stretch/>
            </p:blipFill>
            <p:spPr>
              <a:xfrm>
                <a:off x="6928689" y="3654496"/>
                <a:ext cx="2820008" cy="2870064"/>
              </a:xfrm>
              <a:prstGeom prst="rect">
                <a:avLst/>
              </a:prstGeom>
            </p:spPr>
          </p:pic>
          <p:sp>
            <p:nvSpPr>
              <p:cNvPr id="29" name="Textfeld 28">
                <a:extLst>
                  <a:ext uri="{FF2B5EF4-FFF2-40B4-BE49-F238E27FC236}">
                    <a16:creationId xmlns:a16="http://schemas.microsoft.com/office/drawing/2014/main" id="{6CD58099-6377-4377-90AF-DEFD9960057E}"/>
                  </a:ext>
                </a:extLst>
              </p:cNvPr>
              <p:cNvSpPr txBox="1"/>
              <p:nvPr/>
            </p:nvSpPr>
            <p:spPr>
              <a:xfrm>
                <a:off x="7676332" y="3346944"/>
                <a:ext cx="1692507" cy="4942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positive</a:t>
                </a:r>
                <a:r>
                  <a:rPr lang="de-DE" dirty="0"/>
                  <a:t> </a:t>
                </a:r>
                <a:r>
                  <a:rPr lang="de-DE" sz="1400" dirty="0" err="1"/>
                  <a:t>control</a:t>
                </a:r>
                <a:endParaRPr lang="de-DE" dirty="0"/>
              </a:p>
            </p:txBody>
          </p:sp>
          <p:pic>
            <p:nvPicPr>
              <p:cNvPr id="30" name="Grafik 29">
                <a:extLst>
                  <a:ext uri="{FF2B5EF4-FFF2-40B4-BE49-F238E27FC236}">
                    <a16:creationId xmlns:a16="http://schemas.microsoft.com/office/drawing/2014/main" id="{6B4B05EF-BB17-4DE5-8182-80D508A71A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grayscl/>
              </a:blip>
              <a:srcRect l="7480" b="4343"/>
              <a:stretch/>
            </p:blipFill>
            <p:spPr>
              <a:xfrm>
                <a:off x="3778962" y="637853"/>
                <a:ext cx="2820006" cy="2870063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380551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1</Words>
  <Application>Microsoft Office PowerPoint</Application>
  <PresentationFormat>Breitbild</PresentationFormat>
  <Paragraphs>39</Paragraphs>
  <Slides>9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Office</vt:lpstr>
      <vt:lpstr>Prism 7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anna</dc:creator>
  <cp:lastModifiedBy>Janna</cp:lastModifiedBy>
  <cp:revision>18</cp:revision>
  <dcterms:created xsi:type="dcterms:W3CDTF">2019-11-06T15:29:20Z</dcterms:created>
  <dcterms:modified xsi:type="dcterms:W3CDTF">2019-12-23T14:44:03Z</dcterms:modified>
</cp:coreProperties>
</file>